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  <p:sldId id="272" r:id="rId13"/>
    <p:sldId id="274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7" d="100"/>
          <a:sy n="117" d="100"/>
        </p:scale>
        <p:origin x="6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206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296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81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0219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712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7330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57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26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623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0207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612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AC90D-1F20-4E44-AD6C-573EF0703CD8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4EB20-E502-4ACF-A069-6598D185D6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483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P. sal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4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6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1" name="Grupo 10"/>
          <p:cNvGrpSpPr/>
          <p:nvPr/>
        </p:nvGrpSpPr>
        <p:grpSpPr>
          <a:xfrm>
            <a:off x="3343959" y="127560"/>
            <a:ext cx="8696794" cy="6522596"/>
            <a:chOff x="3343959" y="127560"/>
            <a:chExt cx="8696794" cy="6522596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43959" y="127560"/>
              <a:ext cx="8696794" cy="6522596"/>
            </a:xfrm>
            <a:prstGeom prst="rect">
              <a:avLst/>
            </a:prstGeom>
          </p:spPr>
        </p:pic>
        <p:cxnSp>
          <p:nvCxnSpPr>
            <p:cNvPr id="3" name="Conector recto 2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1723678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4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6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297382" y="173153"/>
            <a:ext cx="8719050" cy="6539288"/>
            <a:chOff x="3297382" y="173153"/>
            <a:chExt cx="8719050" cy="6539288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97382" y="173153"/>
              <a:ext cx="8719050" cy="6539288"/>
            </a:xfrm>
            <a:prstGeom prst="rect">
              <a:avLst/>
            </a:prstGeom>
          </p:spPr>
        </p:pic>
        <p:cxnSp>
          <p:nvCxnSpPr>
            <p:cNvPr id="8" name="Conector recto 7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335916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7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3560618" y="228600"/>
            <a:ext cx="8451272" cy="6338454"/>
            <a:chOff x="3560618" y="228600"/>
            <a:chExt cx="8451272" cy="6338454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60618" y="228600"/>
              <a:ext cx="8451272" cy="6338454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195932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5188205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11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414888" y="169333"/>
            <a:ext cx="8624711" cy="6468533"/>
            <a:chOff x="3414888" y="169333"/>
            <a:chExt cx="8624711" cy="6468533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4888" y="169333"/>
              <a:ext cx="8624711" cy="6468533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42426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304349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8699FE90-CDDB-4CA0-A2B9-6F5FE97D3C50}"/>
              </a:ext>
            </a:extLst>
          </p:cNvPr>
          <p:cNvSpPr/>
          <p:nvPr/>
        </p:nvSpPr>
        <p:spPr>
          <a:xfrm>
            <a:off x="495980" y="1297096"/>
            <a:ext cx="11200040" cy="4074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2000" b="1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upplementary file 1 A-M 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Gautami" panose="020B0502040204020203" pitchFamily="34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  <a:tabLst>
                <a:tab pos="382270" algn="l"/>
              </a:tabLst>
            </a:pPr>
            <a:r>
              <a:rPr lang="en-US" sz="2400" b="1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The evaluation of cytopathic effects in SHK-1 cells infected with </a:t>
            </a:r>
            <a:r>
              <a:rPr lang="en-US" sz="2400" b="1" i="1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P. </a:t>
            </a:r>
            <a:r>
              <a:rPr lang="en-US" sz="2400" b="1" i="1" dirty="0" err="1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almonis</a:t>
            </a:r>
            <a:br>
              <a:rPr lang="en-US" sz="2400" b="1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</a:b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eparate cell culture images under four experimental conditions at days 4, 7 and 11 (dpi): non-infected SHK-1 not treated with DFO (SHK-1), non-infected SHK-1 cells treated with DFO (SHK-1 + DFO), infected SHK-1 cells not treated with DFO (SHK-1 + P.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al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) and SHK-1 cells infected with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P. </a:t>
            </a:r>
            <a:r>
              <a:rPr lang="en-US" i="1" dirty="0" err="1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almonis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 and treated with DFO (SHK-1 + P.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sal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Gautami" panose="020B0502040204020203" pitchFamily="34" charset="0"/>
              </a:rPr>
              <a:t> + DFO). Images were taken with the EVOS® FL Color Imaging System (Invitrogen, Thermo Fisher Scientific Inc, Carlsbad, CA, USA) using 10X objective after 3 PBS-1X washes. The scale bar was added by using the image analysis ImageJ 1.37 software (National Institutes of Health, Bethesda, MD, USA). Scale bar = 260 µM.</a:t>
            </a:r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Gautami" panose="020B0502040204020203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6494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P. sal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7 DPI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8" name="Grupo 7"/>
          <p:cNvGrpSpPr/>
          <p:nvPr/>
        </p:nvGrpSpPr>
        <p:grpSpPr>
          <a:xfrm>
            <a:off x="3217985" y="123090"/>
            <a:ext cx="8815753" cy="6611815"/>
            <a:chOff x="3217985" y="123090"/>
            <a:chExt cx="8815753" cy="6611815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17985" y="123090"/>
              <a:ext cx="8815753" cy="6611815"/>
            </a:xfrm>
            <a:prstGeom prst="rect">
              <a:avLst/>
            </a:prstGeom>
          </p:spPr>
        </p:pic>
        <p:cxnSp>
          <p:nvCxnSpPr>
            <p:cNvPr id="6" name="Conector recto 5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49868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P. sal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11 DPI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316203" y="211015"/>
            <a:ext cx="8651631" cy="6488723"/>
            <a:chOff x="3316203" y="211015"/>
            <a:chExt cx="8651631" cy="6488723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6203" y="211015"/>
              <a:ext cx="8651631" cy="6488723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57070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4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3399552" y="143785"/>
            <a:ext cx="8661400" cy="6496050"/>
            <a:chOff x="3387360" y="171450"/>
            <a:chExt cx="8661400" cy="6496050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7360" y="171450"/>
              <a:ext cx="8661400" cy="6496050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9531694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7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238500" y="152400"/>
            <a:ext cx="8763000" cy="6572250"/>
            <a:chOff x="3238500" y="152400"/>
            <a:chExt cx="8763000" cy="6572250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8500" y="152400"/>
              <a:ext cx="8763000" cy="6572250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614497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DFO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11 DPI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3476367" y="247135"/>
            <a:ext cx="8534400" cy="6400800"/>
            <a:chOff x="3476367" y="247135"/>
            <a:chExt cx="8534400" cy="6400800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76367" y="247135"/>
              <a:ext cx="8534400" cy="6400800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592769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</a:t>
            </a:r>
            <a:r>
              <a:rPr lang="es-CL" sz="2000" b="1" dirty="0"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P. sal</a:t>
            </a:r>
            <a:endParaRPr lang="es-CL" sz="2000" b="1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4 DPI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245640" y="144218"/>
            <a:ext cx="8758185" cy="6568639"/>
            <a:chOff x="3245640" y="144218"/>
            <a:chExt cx="8758185" cy="6568639"/>
          </a:xfrm>
        </p:grpSpPr>
        <p:pic>
          <p:nvPicPr>
            <p:cNvPr id="8" name="Imagen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5640" y="144218"/>
              <a:ext cx="8758185" cy="6568639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9013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</a:t>
            </a:r>
            <a:r>
              <a:rPr lang="es-CL" sz="2000" b="1" dirty="0"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P. sal</a:t>
            </a:r>
            <a:endParaRPr lang="es-CL" sz="2000" b="1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7 DPI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</a:p>
        </p:txBody>
      </p:sp>
      <p:grpSp>
        <p:nvGrpSpPr>
          <p:cNvPr id="3" name="Grupo 2"/>
          <p:cNvGrpSpPr/>
          <p:nvPr/>
        </p:nvGrpSpPr>
        <p:grpSpPr>
          <a:xfrm>
            <a:off x="3164112" y="101793"/>
            <a:ext cx="8826589" cy="6619942"/>
            <a:chOff x="3164112" y="101793"/>
            <a:chExt cx="8826589" cy="6619942"/>
          </a:xfrm>
        </p:grpSpPr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64112" y="101793"/>
              <a:ext cx="8826589" cy="6619942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257924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490898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2">
            <a:extLst>
              <a:ext uri="{FF2B5EF4-FFF2-40B4-BE49-F238E27FC236}">
                <a16:creationId xmlns:a16="http://schemas.microsoft.com/office/drawing/2014/main" id="{A42C6C58-52FB-4A59-9711-B8438F8D02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872" y="574935"/>
            <a:ext cx="2608288" cy="9690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SHK-1 + </a:t>
            </a:r>
            <a:r>
              <a:rPr lang="es-CL" sz="2000" b="1" dirty="0"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P. sal</a:t>
            </a:r>
            <a:endParaRPr lang="es-CL" sz="2000" b="1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s-CL" sz="2000" b="1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Gautami" panose="020B0502040204020203" pitchFamily="34" charset="0"/>
              </a:rPr>
              <a:t>11 DPI </a:t>
            </a: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es-ES" sz="1100" dirty="0">
              <a:effectLst/>
              <a:latin typeface="Calibri" panose="020F0502020204030204" pitchFamily="34" charset="0"/>
              <a:ea typeface="SimSun" panose="02010600030101010101" pitchFamily="2" charset="-122"/>
              <a:cs typeface="Gautami" panose="020B0502040204020203" pitchFamily="34" charset="0"/>
            </a:endParaRPr>
          </a:p>
        </p:txBody>
      </p:sp>
      <p:sp>
        <p:nvSpPr>
          <p:cNvPr id="4" name="Título 1"/>
          <p:cNvSpPr txBox="1">
            <a:spLocks/>
          </p:cNvSpPr>
          <p:nvPr/>
        </p:nvSpPr>
        <p:spPr>
          <a:xfrm>
            <a:off x="300037" y="136785"/>
            <a:ext cx="1309687" cy="438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b="1" u="sng" dirty="0" bmk="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</a:p>
        </p:txBody>
      </p:sp>
      <p:grpSp>
        <p:nvGrpSpPr>
          <p:cNvPr id="2" name="Grupo 1"/>
          <p:cNvGrpSpPr/>
          <p:nvPr/>
        </p:nvGrpSpPr>
        <p:grpSpPr>
          <a:xfrm>
            <a:off x="3403341" y="161645"/>
            <a:ext cx="8512887" cy="6384665"/>
            <a:chOff x="3403341" y="161645"/>
            <a:chExt cx="8512887" cy="6384665"/>
          </a:xfrm>
        </p:grpSpPr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3341" y="161645"/>
              <a:ext cx="8512887" cy="6384665"/>
            </a:xfrm>
            <a:prstGeom prst="rect">
              <a:avLst/>
            </a:prstGeom>
          </p:spPr>
        </p:pic>
        <p:cxnSp>
          <p:nvCxnSpPr>
            <p:cNvPr id="7" name="Conector recto 6"/>
            <p:cNvCxnSpPr/>
            <p:nvPr/>
          </p:nvCxnSpPr>
          <p:spPr>
            <a:xfrm>
              <a:off x="10715625" y="6149435"/>
              <a:ext cx="1152000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551740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7</TotalTime>
  <Words>239</Words>
  <Application>Microsoft Office PowerPoint</Application>
  <PresentationFormat>Widescreen</PresentationFormat>
  <Paragraphs>38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:  “Limiting access to iron decreases infection of Atlantic salmon SHK-1 cells with bacterium Piscirickettsia salmonis”.     Authors: Rodrigo Díaz1, José Troncoso1, Eva Jakob1 and Stanko Skugor2.  1Cargill Innovation Centre,Camino a Pargua km 57, Colaco km 5, Calbuco, Puerto Montt, Chile 2Cargill Innovation Centre, Dirdasstranda 51, 4335, Dirdal, Norway</dc:title>
  <dc:creator>Rodrigo Díaz</dc:creator>
  <cp:lastModifiedBy>Stanko Skugor</cp:lastModifiedBy>
  <cp:revision>16</cp:revision>
  <dcterms:created xsi:type="dcterms:W3CDTF">2020-09-06T03:04:57Z</dcterms:created>
  <dcterms:modified xsi:type="dcterms:W3CDTF">2021-03-18T21:11:57Z</dcterms:modified>
</cp:coreProperties>
</file>